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8F9F42-C709-4C62-827D-2D53B515DB4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461BAC-6933-4872-9E6B-D921897E8E9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D5E136-556F-42A6-9E32-3F5CC2F4775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14E55C-5AD4-4390-B1F7-07C105E32CF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0F707E-8731-4A5F-919A-D387FCBDC4A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6AB642-B53A-44A5-B27E-4357A11A251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D1BF4B-3F27-4810-BA6C-03BC9151A35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D402EF-F7E9-4D77-96D7-2C773C4F2C1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01CC0C-0746-4C4B-9B67-2F2006F91BA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8CA9D6-BE65-4B7C-B390-7316C558C2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DA14F6-4FEC-4C8A-8110-14B2C94FBDA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6D34D7-3492-4902-A151-81C820A2C3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28A0CA3-DF2F-4208-9389-633D7E0249C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533520" y="4495680"/>
            <a:ext cx="1676160" cy="225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1: 50ng rAGR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2: (free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3: 50ng rAGR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4: (free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5: 100ng rAGR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6: (free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7: 100ng rAGR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2971800" y="4495680"/>
            <a:ext cx="184320" cy="36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2286000" y="5181480"/>
            <a:ext cx="4648320" cy="149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343080" indent="-343080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Multiple signals in lane 7 are probably due to protein oligomerisation: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876"/>
              </a:spcBef>
              <a:buClr>
                <a:srgbClr val="000000"/>
              </a:buClr>
              <a:buFont typeface="Arial"/>
              <a:buAutoNum type="alphaLcParenR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AGR3 monomer: 19 kD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876"/>
              </a:spcBef>
              <a:buClr>
                <a:srgbClr val="000000"/>
              </a:buClr>
              <a:buFont typeface="Arial"/>
              <a:buAutoNum type="alphaLcParenR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AGR3 dimer: 38 kD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876"/>
              </a:spcBef>
              <a:buClr>
                <a:srgbClr val="000000"/>
              </a:buClr>
              <a:buFont typeface="Arial"/>
              <a:buAutoNum type="alphaLcParenR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AGR3 trimer: 57 KD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" descr=""/>
          <p:cNvPicPr/>
          <p:nvPr/>
        </p:nvPicPr>
        <p:blipFill>
          <a:blip r:embed="rId1"/>
          <a:stretch/>
        </p:blipFill>
        <p:spPr>
          <a:xfrm>
            <a:off x="2225520" y="1258920"/>
            <a:ext cx="4267440" cy="3552840"/>
          </a:xfrm>
          <a:prstGeom prst="rect">
            <a:avLst/>
          </a:prstGeom>
          <a:ln w="0">
            <a:noFill/>
          </a:ln>
        </p:spPr>
      </p:pic>
      <p:sp>
        <p:nvSpPr>
          <p:cNvPr id="45" name=""/>
          <p:cNvSpPr/>
          <p:nvPr/>
        </p:nvSpPr>
        <p:spPr>
          <a:xfrm>
            <a:off x="1996920" y="3672000"/>
            <a:ext cx="184320" cy="30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922040" y="357336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922040" y="326880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922040" y="296388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922040" y="273528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1922040" y="212580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3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922040" y="182088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922040" y="128736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7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2760480" y="125892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3216240" y="1258920"/>
            <a:ext cx="380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3674880" y="125892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4132080" y="125892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4512960" y="125892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4970160" y="125892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5503680" y="125892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5868720" y="309888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5884560" y="230040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5884200" y="176688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1602360" y="914400"/>
            <a:ext cx="586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kD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160200" y="152280"/>
            <a:ext cx="871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Western Blot detection of AGR3 using mouse monoclonal AGR3 antibody (ab82400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sgarczyk</cp:lastModifiedBy>
  <dcterms:modified xsi:type="dcterms:W3CDTF">2014-12-10T15:52:38Z</dcterms:modified>
  <cp:revision>3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